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C75CBB-1157-40F9-AFF8-8E83DF54C446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8D1B7-231B-4C77-9CA4-7C508C34A9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4346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 smtClean="0"/>
              <a:t>Supplementary </a:t>
            </a:r>
            <a:r>
              <a:rPr lang="en-CA" smtClean="0"/>
              <a:t>Figure </a:t>
            </a:r>
            <a:r>
              <a:rPr lang="en-CA" smtClean="0"/>
              <a:t>8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CC88B7-DE8F-450E-A02D-FEED2AE3504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92095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471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84212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6331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4356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5442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7325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5474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9341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1670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00868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4117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1161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474861" y="251520"/>
            <a:ext cx="4017640" cy="2352860"/>
            <a:chOff x="803525" y="236910"/>
            <a:chExt cx="5082607" cy="2976540"/>
          </a:xfrm>
        </p:grpSpPr>
        <p:cxnSp>
          <p:nvCxnSpPr>
            <p:cNvPr id="4" name="Straight Connector 3"/>
            <p:cNvCxnSpPr/>
            <p:nvPr/>
          </p:nvCxnSpPr>
          <p:spPr>
            <a:xfrm>
              <a:off x="3784032" y="909193"/>
              <a:ext cx="6401" cy="2304257"/>
            </a:xfrm>
            <a:prstGeom prst="line">
              <a:avLst/>
            </a:prstGeom>
            <a:ln w="19050"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Rectangle 4"/>
            <p:cNvSpPr/>
            <p:nvPr/>
          </p:nvSpPr>
          <p:spPr>
            <a:xfrm>
              <a:off x="803525" y="909194"/>
              <a:ext cx="648072" cy="2211294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829374" y="1111928"/>
              <a:ext cx="506168" cy="188596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CA" sz="1400" dirty="0" smtClean="0">
                  <a:solidFill>
                    <a:schemeClr val="bg1"/>
                  </a:solidFill>
                </a:rPr>
                <a:t>RANDMONISATION</a:t>
              </a:r>
              <a:endParaRPr lang="en-CA" sz="1400" dirty="0">
                <a:solidFill>
                  <a:schemeClr val="bg1"/>
                </a:solidFill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1724821" y="909193"/>
              <a:ext cx="2016224" cy="576065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8" name="Rectangle 7"/>
            <p:cNvSpPr/>
            <p:nvPr/>
          </p:nvSpPr>
          <p:spPr>
            <a:xfrm>
              <a:off x="3813053" y="909193"/>
              <a:ext cx="2016224" cy="576065"/>
            </a:xfrm>
            <a:prstGeom prst="rect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9" name="Rectangle 8"/>
            <p:cNvSpPr/>
            <p:nvPr/>
          </p:nvSpPr>
          <p:spPr>
            <a:xfrm>
              <a:off x="1731804" y="2544422"/>
              <a:ext cx="4104456" cy="576065"/>
            </a:xfrm>
            <a:prstGeom prst="rect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160212" y="1012559"/>
              <a:ext cx="1311006" cy="4282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dirty="0" smtClean="0"/>
                <a:t>Tamoxifen</a:t>
              </a:r>
              <a:endParaRPr lang="en-CA" sz="16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28793" y="1015145"/>
              <a:ext cx="1504389" cy="4282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dirty="0" err="1" smtClean="0"/>
                <a:t>Exemestane</a:t>
              </a:r>
              <a:endParaRPr lang="en-CA" sz="16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042704" y="2647788"/>
              <a:ext cx="1504389" cy="4282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dirty="0" err="1" smtClean="0"/>
                <a:t>Exemestane</a:t>
              </a:r>
              <a:endParaRPr lang="en-CA" sz="1600" dirty="0"/>
            </a:p>
          </p:txBody>
        </p:sp>
        <p:cxnSp>
          <p:nvCxnSpPr>
            <p:cNvPr id="13" name="Straight Connector 12"/>
            <p:cNvCxnSpPr/>
            <p:nvPr/>
          </p:nvCxnSpPr>
          <p:spPr>
            <a:xfrm>
              <a:off x="5886132" y="909193"/>
              <a:ext cx="0" cy="2304257"/>
            </a:xfrm>
            <a:prstGeom prst="line">
              <a:avLst/>
            </a:prstGeom>
            <a:ln w="19050"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Left Brace 13"/>
            <p:cNvSpPr/>
            <p:nvPr/>
          </p:nvSpPr>
          <p:spPr>
            <a:xfrm rot="5400000">
              <a:off x="3682421" y="-1347589"/>
              <a:ext cx="216024" cy="4131224"/>
            </a:xfrm>
            <a:prstGeom prst="leftBrace">
              <a:avLst/>
            </a:prstGeom>
            <a:ln w="28575"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603095" y="236910"/>
              <a:ext cx="2549009" cy="3893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dirty="0" smtClean="0"/>
                <a:t>Total of 5-year treatment</a:t>
              </a:r>
              <a:endParaRPr lang="en-CA" sz="14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315541" y="1799489"/>
              <a:ext cx="947442" cy="3504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i="1" dirty="0" smtClean="0"/>
                <a:t>2.5 years</a:t>
              </a:r>
              <a:endParaRPr lang="en-CA" sz="1200" i="1" dirty="0"/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 flipV="1">
              <a:off x="1451597" y="1269235"/>
              <a:ext cx="201216" cy="648071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>
              <a:off x="1451597" y="2205338"/>
              <a:ext cx="201216" cy="642505"/>
            </a:xfrm>
            <a:prstGeom prst="straightConnector1">
              <a:avLst/>
            </a:prstGeom>
            <a:ln w="190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4" name="TextBox 33"/>
          <p:cNvSpPr txBox="1"/>
          <p:nvPr/>
        </p:nvSpPr>
        <p:spPr>
          <a:xfrm>
            <a:off x="207100" y="2987824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B</a:t>
            </a:r>
            <a:endParaRPr lang="en-CA" sz="20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191613" y="308543"/>
            <a:ext cx="389801" cy="4441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 smtClean="0"/>
              <a:t>A</a:t>
            </a:r>
            <a:endParaRPr lang="en-CA" b="1" dirty="0"/>
          </a:p>
        </p:txBody>
      </p:sp>
      <p:grpSp>
        <p:nvGrpSpPr>
          <p:cNvPr id="20" name="Group 19"/>
          <p:cNvGrpSpPr/>
          <p:nvPr/>
        </p:nvGrpSpPr>
        <p:grpSpPr>
          <a:xfrm>
            <a:off x="836712" y="6112429"/>
            <a:ext cx="5523596" cy="2646319"/>
            <a:chOff x="371568" y="4211960"/>
            <a:chExt cx="6145862" cy="3953441"/>
          </a:xfrm>
        </p:grpSpPr>
        <p:sp>
          <p:nvSpPr>
            <p:cNvPr id="25" name="Rectangle 24"/>
            <p:cNvSpPr/>
            <p:nvPr/>
          </p:nvSpPr>
          <p:spPr>
            <a:xfrm>
              <a:off x="2440759" y="4211960"/>
              <a:ext cx="2224236" cy="611283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accent4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200" dirty="0" smtClean="0">
                  <a:solidFill>
                    <a:schemeClr val="tx1"/>
                  </a:solidFill>
                </a:rPr>
                <a:t>4,736 patients TEAM Pathology Biobank</a:t>
              </a:r>
              <a:endParaRPr lang="en-CA" sz="1200" dirty="0">
                <a:solidFill>
                  <a:schemeClr val="tx1"/>
                </a:solidFill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2443341" y="5257515"/>
              <a:ext cx="2224236" cy="826653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accent4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200" dirty="0" smtClean="0">
                  <a:solidFill>
                    <a:schemeClr val="tx1"/>
                  </a:solidFill>
                </a:rPr>
                <a:t>sufficient RNA and successfully assayed</a:t>
              </a:r>
            </a:p>
            <a:p>
              <a:pPr algn="ctr"/>
              <a:r>
                <a:rPr lang="en-CA" sz="1200" dirty="0" smtClean="0">
                  <a:solidFill>
                    <a:schemeClr val="tx1"/>
                  </a:solidFill>
                </a:rPr>
                <a:t>n=3825</a:t>
              </a:r>
              <a:endParaRPr lang="en-CA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31" name="Straight Arrow Connector 30"/>
            <p:cNvCxnSpPr/>
            <p:nvPr/>
          </p:nvCxnSpPr>
          <p:spPr>
            <a:xfrm>
              <a:off x="3564104" y="4910471"/>
              <a:ext cx="0" cy="309601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Rectangle 35"/>
            <p:cNvSpPr/>
            <p:nvPr/>
          </p:nvSpPr>
          <p:spPr>
            <a:xfrm>
              <a:off x="415710" y="6629040"/>
              <a:ext cx="2589522" cy="648072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accent4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200" dirty="0" smtClean="0">
                  <a:solidFill>
                    <a:schemeClr val="tx1"/>
                  </a:solidFill>
                </a:rPr>
                <a:t>Training Cohort</a:t>
              </a:r>
            </a:p>
            <a:p>
              <a:pPr algn="ctr"/>
              <a:r>
                <a:rPr lang="en-CA" sz="1200" dirty="0" smtClean="0">
                  <a:solidFill>
                    <a:schemeClr val="tx1"/>
                  </a:solidFill>
                </a:rPr>
                <a:t>n=790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3921049" y="6629040"/>
              <a:ext cx="2589522" cy="648072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accent4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200" dirty="0" smtClean="0">
                  <a:solidFill>
                    <a:schemeClr val="tx1"/>
                  </a:solidFill>
                </a:rPr>
                <a:t>Validation Cohort</a:t>
              </a:r>
            </a:p>
            <a:p>
              <a:pPr algn="ctr"/>
              <a:r>
                <a:rPr lang="en-CA" sz="1200" dirty="0" smtClean="0">
                  <a:solidFill>
                    <a:schemeClr val="tx1"/>
                  </a:solidFill>
                </a:rPr>
                <a:t>n=3,035</a:t>
              </a:r>
              <a:endParaRPr lang="en-CA" sz="1200" dirty="0">
                <a:solidFill>
                  <a:schemeClr val="tx1"/>
                </a:solidFill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371568" y="7349120"/>
              <a:ext cx="2506608" cy="8162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200" dirty="0" smtClean="0"/>
                <a:t>Endocrine treated only = 576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endParaRPr lang="en-US" sz="12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200" dirty="0" smtClean="0"/>
                <a:t>Endocrine + adjuvant = 214</a:t>
              </a:r>
              <a:endParaRPr lang="en-US" sz="12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886936" y="7343304"/>
              <a:ext cx="2592984" cy="8162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200" dirty="0" smtClean="0"/>
                <a:t>Endocrine treated only = 1974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endParaRPr lang="en-US" sz="12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200" dirty="0" smtClean="0"/>
                <a:t>Endocrine + adjuvant =1062</a:t>
              </a:r>
              <a:endParaRPr lang="en-US" sz="1200" dirty="0"/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>
              <a:off x="1720199" y="6319439"/>
              <a:ext cx="0" cy="309601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>
              <a:off x="5243574" y="6317038"/>
              <a:ext cx="0" cy="309601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1710471" y="6319439"/>
              <a:ext cx="3537943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3552877" y="6084168"/>
              <a:ext cx="0" cy="235271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>
              <a:stCxn id="2" idx="1"/>
              <a:endCxn id="2" idx="3"/>
            </p:cNvCxnSpPr>
            <p:nvPr/>
          </p:nvCxnSpPr>
          <p:spPr>
            <a:xfrm>
              <a:off x="371568" y="7757261"/>
              <a:ext cx="250660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3932620" y="7771546"/>
              <a:ext cx="25848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9" name="TextBox 38"/>
          <p:cNvSpPr txBox="1"/>
          <p:nvPr/>
        </p:nvSpPr>
        <p:spPr>
          <a:xfrm>
            <a:off x="222045" y="6111810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C</a:t>
            </a:r>
            <a:endParaRPr lang="en-CA" sz="2000" b="1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0958" y="3059832"/>
            <a:ext cx="3179519" cy="2725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7742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Jane Bayani</cp:lastModifiedBy>
  <cp:revision>6</cp:revision>
  <dcterms:created xsi:type="dcterms:W3CDTF">2016-05-05T14:49:32Z</dcterms:created>
  <dcterms:modified xsi:type="dcterms:W3CDTF">2016-07-29T18:37:50Z</dcterms:modified>
</cp:coreProperties>
</file>